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F5E815-3EA8-49D2-ADF7-D72FE16D737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FABEEA-968C-42BB-A4CC-BC488F8C15D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6ADA51-B672-4C15-9DF8-41F7F9CF718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5543EF-65B8-41BB-9152-A884C102AA3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50A4AC-ACB8-4C55-AC8C-30BCCD64F5E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E1362A-F1B8-447C-81C6-4A39636C8FC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A809D5-9D97-4B75-9A49-373FDDD3A18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4F5FFA-44C3-49E5-AB25-E6BDAB5B073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B96E3C-E09E-47FF-81E4-2EC0ECB83E3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C2E3C9-F632-4959-B886-EFDD49EEF74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DB2D18-E41A-47FA-8BF8-5A3E3E55EC5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0C464A-66B5-4783-864C-103FA0C8DFD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F97D602-94A0-41D9-A38C-850A5157D5F1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12"/>
          <p:cNvSpPr/>
          <p:nvPr/>
        </p:nvSpPr>
        <p:spPr>
          <a:xfrm>
            <a:off x="165600" y="152280"/>
            <a:ext cx="29070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Arial"/>
              </a:rPr>
              <a:t>Supplemental Figure 1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TextBox 13"/>
          <p:cNvSpPr/>
          <p:nvPr/>
        </p:nvSpPr>
        <p:spPr>
          <a:xfrm>
            <a:off x="599040" y="5029200"/>
            <a:ext cx="839052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l figure 1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harmacokinetics and predicted pharmacodynamics of Nec-1.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a)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harmacokinetic profile of Nec-1 dosed i.p.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t 10 mg/kg in C57BL/6 mice. The data represent the combined results of the three independent animals. Error bars indicate standard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eviations. (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 Modeling of predicted % inhibition against RIP1 using the observed pharmacokinetic profile of Nec-1 in conjunction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with the potency in inhibiting TNF and zVAD necroptosis in mouse L929 cells.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3" name="Picture 2" descr=""/>
          <p:cNvPicPr/>
          <p:nvPr/>
        </p:nvPicPr>
        <p:blipFill>
          <a:blip r:embed="rId1"/>
          <a:stretch/>
        </p:blipFill>
        <p:spPr>
          <a:xfrm>
            <a:off x="228600" y="1219320"/>
            <a:ext cx="4495680" cy="2743200"/>
          </a:xfrm>
          <a:prstGeom prst="rect">
            <a:avLst/>
          </a:prstGeom>
          <a:ln w="0">
            <a:noFill/>
          </a:ln>
        </p:spPr>
      </p:pic>
      <p:pic>
        <p:nvPicPr>
          <p:cNvPr id="44" name="Picture 3" descr=""/>
          <p:cNvPicPr/>
          <p:nvPr/>
        </p:nvPicPr>
        <p:blipFill>
          <a:blip r:embed="rId2"/>
          <a:stretch/>
        </p:blipFill>
        <p:spPr>
          <a:xfrm>
            <a:off x="5029200" y="1219320"/>
            <a:ext cx="3979800" cy="2743200"/>
          </a:xfrm>
          <a:prstGeom prst="rect">
            <a:avLst/>
          </a:prstGeom>
          <a:ln w="0">
            <a:noFill/>
          </a:ln>
        </p:spPr>
      </p:pic>
      <p:sp>
        <p:nvSpPr>
          <p:cNvPr id="45" name="TextBox 9"/>
          <p:cNvSpPr/>
          <p:nvPr/>
        </p:nvSpPr>
        <p:spPr>
          <a:xfrm>
            <a:off x="535680" y="1143000"/>
            <a:ext cx="3225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TextBox 10"/>
          <p:cNvSpPr/>
          <p:nvPr/>
        </p:nvSpPr>
        <p:spPr>
          <a:xfrm>
            <a:off x="4879080" y="1143000"/>
            <a:ext cx="3225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7-31T14:59:13Z</dcterms:created>
  <dc:creator>rqn12777</dc:creator>
  <dc:description/>
  <dc:language>en-US</dc:language>
  <cp:lastModifiedBy>Satish.d</cp:lastModifiedBy>
  <dcterms:modified xsi:type="dcterms:W3CDTF">2015-07-21T06:29:42Z</dcterms:modified>
  <cp:revision>10</cp:revision>
  <dc:subject/>
  <dc:title>Slide 1</dc:title>
</cp:coreProperties>
</file>